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71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8D644E-1DDD-40A1-AA55-E1E9E0380F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A11F135-B0CB-4959-9860-DB67346DAE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219541-16F6-4D31-8426-58F556D42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BF5EA-8A29-4543-A890-BD8744C45177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7D39C6-5DB3-4A27-AA20-E381041F2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D2A26A-BE11-4621-8479-2E631FB4FC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F9D0A-19BF-448C-87CD-4B151563D0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0690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A0CAA5-6543-4525-B311-F9DDD6640F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6D6CD1-958E-42C5-A31B-7A52DDCEA7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A49927-4AC6-468F-8F97-EA9F8960B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BF5EA-8A29-4543-A890-BD8744C45177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9130DB-E992-4050-BB72-FC5B3C1FC9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A0AD28-319E-46E6-B61D-39C423360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F9D0A-19BF-448C-87CD-4B151563D0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64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474E76-D196-4BD1-A204-FA5115C88A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B1A4D8-D401-407B-AB84-97C5E9BF3E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259687-6866-44E3-9321-DA152D8911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BF5EA-8A29-4543-A890-BD8744C45177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6C4FAD-CA2A-482B-8F64-66171E3F57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510D1C-E932-403F-966D-8E696A4EFF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F9D0A-19BF-448C-87CD-4B151563D0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55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1FD573-17F4-4696-AA77-719046933A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E85CC1-CD37-4355-8948-D01E4677DB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A74E9E-9061-45A2-93ED-342309645C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BF5EA-8A29-4543-A890-BD8744C45177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2D9EF2-1962-4BD5-BB1D-E13A1A865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880466-5000-4A4D-977C-DF07948A55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F9D0A-19BF-448C-87CD-4B151563D0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685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3B6B80-FE29-425B-89C8-9985042EF6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4457D4-0AC8-42B4-9BF0-60664E1D2C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2E5B40-B16E-4635-BA22-0E149E922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BF5EA-8A29-4543-A890-BD8744C45177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70F06B-E4AF-422C-8E37-AAFBCCDB9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0EBECC-53B3-4AEB-82EF-C15755A50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F9D0A-19BF-448C-87CD-4B151563D0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66230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3DF2F6-448B-49EE-AAE1-13B582AA54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9E9772-ECCC-47DD-8BBA-2E0FF861CF5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A9EAD53-09AB-4C4C-8917-3B36E989F3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A860A8-54AD-4A77-A18B-0C6EAA03E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BF5EA-8A29-4543-A890-BD8744C45177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86275D-20A4-4112-9831-C212C9707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C6E04C-563E-4AF5-BF73-B2945129C0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F9D0A-19BF-448C-87CD-4B151563D0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1425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A4498B-662F-4988-A46E-DC6E4C89B7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5A50A2-ABDF-4E8D-AE61-FE0004A234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3FA07D-76D3-4E1C-899E-D928DC51DB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024D521-A742-4C69-A359-44CE6A965A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91F2D28-F4CF-44ED-BE36-31AD226CAB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D3EA474-2551-4D4B-84C6-8198CC22E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BF5EA-8A29-4543-A890-BD8744C45177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38B77BC-451B-4A95-A245-036465118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DEB7EAC-7449-41E9-B807-A00F06AAE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F9D0A-19BF-448C-87CD-4B151563D0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990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36F032-8FC6-4A09-B738-42895F76D7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29A336-A60E-4AC0-B190-80F0C02535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BF5EA-8A29-4543-A890-BD8744C45177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8C0AA91-04AD-4EE2-A1FE-B937B91D6C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738EFA-0DB3-4D65-810C-22021C0819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F9D0A-19BF-448C-87CD-4B151563D0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390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128E441-809D-4B75-A5A4-FCDDD867C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BF5EA-8A29-4543-A890-BD8744C45177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C4C4556-B449-4525-BF23-9451A698A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298A83A-81A1-49F3-9F28-CD42963964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F9D0A-19BF-448C-87CD-4B151563D0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406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9783B4-AAAD-4325-AB07-8E3536FAC1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60C43D-9188-461A-A460-E9D1B49866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6AB9F5-762A-4383-A7C6-3B88E0ECDB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1A6C1D-C394-4970-834F-2C9F845A8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BF5EA-8A29-4543-A890-BD8744C45177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C9A0DE-B7F0-4BCC-9406-95770AA78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716015-DA70-4529-8E00-A8C588B50D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F9D0A-19BF-448C-87CD-4B151563D0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383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EF6C4B-FB68-43FA-93B7-82B971395D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ACB872E-8F2E-431A-82AB-F21086EE4F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5446D7E-A63B-4FE2-866D-B103B3A68F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AC64A9-948C-44BA-A818-6386323F85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3BF5EA-8A29-4543-A890-BD8744C45177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ABF928-3926-470A-A786-B0E1B92A6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80C326-0863-44E7-8199-79DEBEEA69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1F9D0A-19BF-448C-87CD-4B151563D0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3850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CB4700F-85E0-40CD-A1E5-E394945F34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019E13-6774-401C-93F5-DA142663B4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8A48DC-8250-4CE3-82F9-EAD2D8F683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3BF5EA-8A29-4543-A890-BD8744C45177}" type="datetimeFigureOut">
              <a:rPr lang="en-US" smtClean="0"/>
              <a:t>3/2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B258DB-4142-4CA5-BD27-A730E7F676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EA8D7B-9DCD-4D21-85E4-1EAA1A4E0B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1F9D0A-19BF-448C-87CD-4B151563D0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710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FADD89EF-7D54-46E2-AB9B-D50E6D679B4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sz="2000" b="1" dirty="0"/>
              <a:t>Dual colour labelled cFos</a:t>
            </a:r>
          </a:p>
          <a:p>
            <a:r>
              <a:rPr lang="en-GB" sz="1600" dirty="0"/>
              <a:t>This movie shows both molecules offset on the y-axis to permit clearer visualisation of their colocalised movement. The two Qdot labels have emission maxima at 605 and 655 nm.</a:t>
            </a:r>
            <a:endParaRPr lang="en-US" sz="1600" dirty="0"/>
          </a:p>
          <a:p>
            <a:endParaRPr lang="en-US" dirty="0"/>
          </a:p>
        </p:txBody>
      </p:sp>
      <p:pic>
        <p:nvPicPr>
          <p:cNvPr id="2" name="Fos Homodimer_comp">
            <a:hlinkClick r:id="" action="ppaction://media"/>
            <a:extLst>
              <a:ext uri="{FF2B5EF4-FFF2-40B4-BE49-F238E27FC236}">
                <a16:creationId xmlns:a16="http://schemas.microsoft.com/office/drawing/2014/main" id="{49E515B1-8DB7-4D52-B6E2-90F4000F0557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910633" y="474548"/>
            <a:ext cx="10800000" cy="2672449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214209721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40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FADD89EF-7D54-46E2-AB9B-D50E6D679B4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sz="2000" b="1" dirty="0"/>
              <a:t>Dual colour labelled cJun</a:t>
            </a:r>
          </a:p>
          <a:p>
            <a:r>
              <a:rPr lang="en-GB" sz="1600" dirty="0"/>
              <a:t>This movie shows both molecules offset on the y-axis to permit clearer visualisation of their colocalised movement. The two Qdot labels have emission maxima at 605 and 655 nm.</a:t>
            </a:r>
            <a:endParaRPr lang="en-US" sz="1600" dirty="0"/>
          </a:p>
          <a:p>
            <a:endParaRPr lang="en-US" dirty="0"/>
          </a:p>
        </p:txBody>
      </p:sp>
      <p:pic>
        <p:nvPicPr>
          <p:cNvPr id="4" name="Jun Homodimer_comp">
            <a:hlinkClick r:id="" action="ppaction://media"/>
            <a:extLst>
              <a:ext uri="{FF2B5EF4-FFF2-40B4-BE49-F238E27FC236}">
                <a16:creationId xmlns:a16="http://schemas.microsoft.com/office/drawing/2014/main" id="{494415FA-3834-47A0-ACDB-4A98145EB37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714245" y="341792"/>
            <a:ext cx="10800000" cy="3097675"/>
          </a:xfrm>
          <a:prstGeom prst="rect">
            <a:avLst/>
          </a:prstGeom>
          <a:ln w="3810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341205656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3999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70</Words>
  <Application>Microsoft Office PowerPoint</Application>
  <PresentationFormat>Widescreen</PresentationFormat>
  <Paragraphs>4</Paragraphs>
  <Slides>2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 Kad</dc:creator>
  <cp:lastModifiedBy>Neil Kad</cp:lastModifiedBy>
  <cp:revision>2</cp:revision>
  <dcterms:created xsi:type="dcterms:W3CDTF">2022-03-08T13:44:04Z</dcterms:created>
  <dcterms:modified xsi:type="dcterms:W3CDTF">2022-03-23T10:13:53Z</dcterms:modified>
</cp:coreProperties>
</file>